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</p:sldIdLst>
  <p:sldSz cx="6858000" cy="9144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4660"/>
  </p:normalViewPr>
  <p:slideViewPr>
    <p:cSldViewPr>
      <p:cViewPr>
        <p:scale>
          <a:sx n="200" d="100"/>
          <a:sy n="200" d="100"/>
        </p:scale>
        <p:origin x="-498" y="721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83669-FC1A-4BC4-8791-54B62EF89FF7}" type="datetimeFigureOut">
              <a:rPr kumimoji="1" lang="ja-JP" altLang="en-US" smtClean="0"/>
              <a:t>2019/8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52F5A-6817-40FF-9F0D-050EBAB33C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05296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83669-FC1A-4BC4-8791-54B62EF89FF7}" type="datetimeFigureOut">
              <a:rPr kumimoji="1" lang="ja-JP" altLang="en-US" smtClean="0"/>
              <a:t>2019/8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52F5A-6817-40FF-9F0D-050EBAB33C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200032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83669-FC1A-4BC4-8791-54B62EF89FF7}" type="datetimeFigureOut">
              <a:rPr kumimoji="1" lang="ja-JP" altLang="en-US" smtClean="0"/>
              <a:t>2019/8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52F5A-6817-40FF-9F0D-050EBAB33C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518068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83669-FC1A-4BC4-8791-54B62EF89FF7}" type="datetimeFigureOut">
              <a:rPr kumimoji="1" lang="ja-JP" altLang="en-US" smtClean="0"/>
              <a:t>2019/8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52F5A-6817-40FF-9F0D-050EBAB33C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419545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83669-FC1A-4BC4-8791-54B62EF89FF7}" type="datetimeFigureOut">
              <a:rPr kumimoji="1" lang="ja-JP" altLang="en-US" smtClean="0"/>
              <a:t>2019/8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52F5A-6817-40FF-9F0D-050EBAB33C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029192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83669-FC1A-4BC4-8791-54B62EF89FF7}" type="datetimeFigureOut">
              <a:rPr kumimoji="1" lang="ja-JP" altLang="en-US" smtClean="0"/>
              <a:t>2019/8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52F5A-6817-40FF-9F0D-050EBAB33C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763460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83669-FC1A-4BC4-8791-54B62EF89FF7}" type="datetimeFigureOut">
              <a:rPr kumimoji="1" lang="ja-JP" altLang="en-US" smtClean="0"/>
              <a:t>2019/8/28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52F5A-6817-40FF-9F0D-050EBAB33C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559960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83669-FC1A-4BC4-8791-54B62EF89FF7}" type="datetimeFigureOut">
              <a:rPr kumimoji="1" lang="ja-JP" altLang="en-US" smtClean="0"/>
              <a:t>2019/8/2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52F5A-6817-40FF-9F0D-050EBAB33C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644524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83669-FC1A-4BC4-8791-54B62EF89FF7}" type="datetimeFigureOut">
              <a:rPr kumimoji="1" lang="ja-JP" altLang="en-US" smtClean="0"/>
              <a:t>2019/8/28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52F5A-6817-40FF-9F0D-050EBAB33C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67882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83669-FC1A-4BC4-8791-54B62EF89FF7}" type="datetimeFigureOut">
              <a:rPr kumimoji="1" lang="ja-JP" altLang="en-US" smtClean="0"/>
              <a:t>2019/8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52F5A-6817-40FF-9F0D-050EBAB33C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981338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83669-FC1A-4BC4-8791-54B62EF89FF7}" type="datetimeFigureOut">
              <a:rPr kumimoji="1" lang="ja-JP" altLang="en-US" smtClean="0"/>
              <a:t>2019/8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52F5A-6817-40FF-9F0D-050EBAB33C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865555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A83669-FC1A-4BC4-8791-54B62EF89FF7}" type="datetimeFigureOut">
              <a:rPr kumimoji="1" lang="ja-JP" altLang="en-US" smtClean="0"/>
              <a:t>2019/8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252F5A-6817-40FF-9F0D-050EBAB33C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688356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 descr="C:\Users\motohashi_inspiron\Desktop\190805_DNA-detectionSYSTEM_parts\P8050356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5400000">
            <a:off x="2359006" y="5137646"/>
            <a:ext cx="2799312" cy="209948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正方形/長方形 4"/>
          <p:cNvSpPr/>
          <p:nvPr/>
        </p:nvSpPr>
        <p:spPr>
          <a:xfrm>
            <a:off x="404664" y="8387793"/>
            <a:ext cx="6169121" cy="6001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ja-JP" sz="1100" b="1" dirty="0" smtClean="0"/>
              <a:t>S3 Fig. </a:t>
            </a:r>
            <a:r>
              <a:rPr lang="en-US" altLang="ja-JP" sz="1100" b="1" dirty="0"/>
              <a:t>A photograph of DNA agarose gel electrophoresis detection systems developed in this </a:t>
            </a:r>
            <a:r>
              <a:rPr lang="en-US" altLang="ja-JP" sz="1100" b="1" dirty="0" smtClean="0"/>
              <a:t>study. </a:t>
            </a:r>
            <a:r>
              <a:rPr lang="en-US" altLang="ja-JP" sz="1100" dirty="0" smtClean="0"/>
              <a:t>Gel </a:t>
            </a:r>
            <a:r>
              <a:rPr lang="en-US" altLang="ja-JP" sz="1100" dirty="0"/>
              <a:t>images were recorded with a digital camera </a:t>
            </a:r>
            <a:r>
              <a:rPr lang="en-US" altLang="ja-JP" sz="1100" dirty="0" err="1" smtClean="0"/>
              <a:t>PowerShot</a:t>
            </a:r>
            <a:r>
              <a:rPr lang="en-US" altLang="ja-JP" sz="1100" dirty="0" smtClean="0"/>
              <a:t> </a:t>
            </a:r>
            <a:r>
              <a:rPr lang="en-US" altLang="ja-JP" sz="1100" dirty="0"/>
              <a:t>G12 (Canon) </a:t>
            </a:r>
            <a:r>
              <a:rPr lang="en-US" altLang="ja-JP" sz="1100" dirty="0" smtClean="0"/>
              <a:t>in a </a:t>
            </a:r>
            <a:r>
              <a:rPr lang="en-US" altLang="ja-JP" sz="1100" dirty="0"/>
              <a:t>dark place shaded by </a:t>
            </a:r>
            <a:r>
              <a:rPr lang="en-US" altLang="ja-JP" sz="1100" dirty="0" smtClean="0"/>
              <a:t>blackout </a:t>
            </a:r>
            <a:r>
              <a:rPr lang="en-US" altLang="ja-JP" sz="1100" dirty="0"/>
              <a:t>curtain. (a) Blue-LED system; (b) Cyan-LED + Excitation-filter system; (c) Black light system.</a:t>
            </a:r>
            <a:endParaRPr lang="ja-JP" altLang="en-US" sz="1100" dirty="0"/>
          </a:p>
        </p:txBody>
      </p:sp>
      <p:pic>
        <p:nvPicPr>
          <p:cNvPr id="3075" name="Picture 3" descr="C:\Users\motohashi_inspiron\Desktop\190805_DNA-detectionSYSTEM_parts\P8050360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5400000">
            <a:off x="918847" y="1321514"/>
            <a:ext cx="2799310" cy="209948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76" name="Picture 4" descr="C:\Users\motohashi_inspiron\Desktop\190805_DNA-detectionSYSTEM_parts\P8050358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5400000">
            <a:off x="3582143" y="1322513"/>
            <a:ext cx="2807299" cy="210547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テキスト ボックス 7"/>
          <p:cNvSpPr txBox="1"/>
          <p:nvPr/>
        </p:nvSpPr>
        <p:spPr>
          <a:xfrm>
            <a:off x="1455990" y="3750325"/>
            <a:ext cx="17250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Blue-LED </a:t>
            </a:r>
            <a:r>
              <a:rPr lang="en-US" altLang="ja-JP" dirty="0" smtClean="0"/>
              <a:t>sy</a:t>
            </a:r>
            <a:r>
              <a:rPr kumimoji="1" lang="en-US" altLang="ja-JP" dirty="0" smtClean="0"/>
              <a:t>stem</a:t>
            </a:r>
            <a:endParaRPr kumimoji="1" lang="ja-JP" altLang="en-US" dirty="0"/>
          </a:p>
        </p:txBody>
      </p:sp>
      <p:sp>
        <p:nvSpPr>
          <p:cNvPr id="9" name="テキスト ボックス 8"/>
          <p:cNvSpPr txBox="1"/>
          <p:nvPr/>
        </p:nvSpPr>
        <p:spPr>
          <a:xfrm>
            <a:off x="3627920" y="3750325"/>
            <a:ext cx="271574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 smtClean="0"/>
              <a:t>Cyan-LED + Excitation-filter</a:t>
            </a:r>
          </a:p>
          <a:p>
            <a:pPr algn="ctr"/>
            <a:r>
              <a:rPr lang="en-US" altLang="ja-JP" dirty="0" smtClean="0"/>
              <a:t>system</a:t>
            </a:r>
            <a:endParaRPr kumimoji="1" lang="ja-JP" altLang="en-US" dirty="0"/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2837897" y="7587044"/>
            <a:ext cx="18415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Black light system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1811147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61</TotalTime>
  <Words>69</Words>
  <Application>Microsoft Office PowerPoint</Application>
  <PresentationFormat>画面に合わせる (4:3)</PresentationFormat>
  <Paragraphs>5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​​テーマ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otohashi</dc:creator>
  <cp:lastModifiedBy>motohashi_inspiron</cp:lastModifiedBy>
  <cp:revision>124</cp:revision>
  <dcterms:created xsi:type="dcterms:W3CDTF">2019-01-13T10:10:36Z</dcterms:created>
  <dcterms:modified xsi:type="dcterms:W3CDTF">2019-08-28T02:19:16Z</dcterms:modified>
</cp:coreProperties>
</file>